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14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000000"/>
          </p15:clr>
        </p15:guide>
        <p15:guide id="2" pos="2880">
          <p15:clr>
            <a:srgbClr val="000000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07BD36B8-DC60-4912-8DF0-F89753BA78F9}">
  <a:tblStyle styleId="{07BD36B8-DC60-4912-8DF0-F89753BA78F9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wholeTbl>
    <a:band1H>
      <a:tcTxStyle/>
      <a:tcStyle>
        <a:tcBdr/>
        <a:fill>
          <a:solidFill>
            <a:schemeClr val="dk1">
              <a:alpha val="20000"/>
            </a:schemeClr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chemeClr val="dk1">
              <a:alpha val="20000"/>
            </a:schemeClr>
          </a:solidFill>
        </a:fill>
      </a:tcStyle>
    </a:band1V>
    <a:band2V>
      <a:tcTxStyle/>
      <a:tcStyle>
        <a:tcBdr/>
      </a:tcStyle>
    </a:band2V>
    <a:lastCol>
      <a:tcTxStyle b="on" i="off"/>
      <a:tcStyle>
        <a:tcBdr/>
      </a:tcStyle>
    </a:lastCol>
    <a:firstCol>
      <a:tcTxStyle b="on" i="off"/>
      <a:tcStyle>
        <a:tcBdr/>
      </a:tcStyle>
    </a:firstCol>
    <a:lastRow>
      <a:tcTxStyle b="on" i="off"/>
      <a:tcStyle>
        <a:tcBdr>
          <a:top>
            <a:ln w="508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rgbClr val="FFFFFF">
              <a:alpha val="0"/>
            </a:srgbClr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/>
      <a:tcStyle>
        <a:tcBdr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rgbClr val="FFFFFF">
              <a:alpha val="0"/>
            </a:srgbClr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5"/>
    <p:restoredTop sz="94674"/>
  </p:normalViewPr>
  <p:slideViewPr>
    <p:cSldViewPr snapToGrid="0">
      <p:cViewPr varScale="1">
        <p:scale>
          <a:sx n="124" d="100"/>
          <a:sy n="124" d="100"/>
        </p:scale>
        <p:origin x="74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6" name="Google Shape;136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Google Shape;141;p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2" name="Google Shape;142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8" name="Google Shape;148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4" name="Google Shape;94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0" name="Google Shape;100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6" name="Google Shape;106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p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2" name="Google Shape;112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8" name="Google Shape;118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Google Shape;123;p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4" name="Google Shape;124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Google Shape;129;p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0" name="Google Shape;130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lvl="0" algn="ctr">
              <a:spcBef>
                <a:spcPts val="640"/>
              </a:spcBef>
              <a:spcAft>
                <a:spcPts val="0"/>
              </a:spcAft>
              <a:buClr>
                <a:srgbClr val="888888"/>
              </a:buClr>
              <a:buSzPts val="3200"/>
              <a:buNone/>
              <a:defRPr>
                <a:solidFill>
                  <a:srgbClr val="888888"/>
                </a:solidFill>
              </a:defRPr>
            </a:lvl1pPr>
            <a:lvl2pPr lvl="1" algn="ctr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None/>
              <a:defRPr>
                <a:solidFill>
                  <a:srgbClr val="888888"/>
                </a:solidFill>
              </a:defRPr>
            </a:lvl2pPr>
            <a:lvl3pPr lvl="2" algn="ctr">
              <a:spcBef>
                <a:spcPts val="48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>
                <a:solidFill>
                  <a:srgbClr val="888888"/>
                </a:solidFill>
              </a:defRPr>
            </a:lvl3pPr>
            <a:lvl4pPr lvl="3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4pPr>
            <a:lvl5pPr lvl="4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5pPr>
            <a:lvl6pPr lvl="5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6pPr>
            <a:lvl7pPr lvl="6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7pPr>
            <a:lvl8pPr lvl="7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8pPr>
            <a:lvl9pPr lvl="8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2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2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2309018" y="-251619"/>
            <a:ext cx="4525963" cy="822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4732337" y="2171700"/>
            <a:ext cx="5851525" cy="2057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541338" y="190501"/>
            <a:ext cx="5851525" cy="601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3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3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3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4"/>
          <p:cNvSpPr txBox="1"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sz="4000" b="1" cap="none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lvl="0" indent="-228600" algn="l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1pPr>
            <a:lvl2pPr marL="914400" lvl="1" indent="-228600" algn="l"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2pPr>
            <a:lvl3pPr marL="1371600" lvl="2" indent="-228600" algn="l"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3pPr>
            <a:lvl4pPr marL="1828800" lvl="3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4pPr>
            <a:lvl5pPr marL="2286000" lvl="4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5pPr>
            <a:lvl6pPr marL="2743200" lvl="5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6pPr>
            <a:lvl7pPr marL="3200400" lvl="6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7pPr>
            <a:lvl8pPr marL="3657600" lvl="7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8pPr>
            <a:lvl9pPr marL="4114800" lvl="8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5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body" idx="2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33" name="Google Shape;33;p5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5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6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lvl="0" indent="-2286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body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40" name="Google Shape;40;p6"/>
          <p:cNvSpPr txBox="1">
            <a:spLocks noGrp="1"/>
          </p:cNvSpPr>
          <p:nvPr>
            <p:ph type="body" idx="3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lvl="0" indent="-2286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6"/>
          <p:cNvSpPr txBox="1">
            <a:spLocks noGrp="1"/>
          </p:cNvSpPr>
          <p:nvPr>
            <p:ph type="body" idx="4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6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7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7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431800" algn="l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–"/>
              <a:defRPr sz="2800"/>
            </a:lvl2pPr>
            <a:lvl3pPr marL="1371600" lvl="2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4pPr>
            <a:lvl5pPr marL="2286000" lvl="4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»"/>
              <a:defRPr sz="2000"/>
            </a:lvl5pPr>
            <a:lvl6pPr marL="2743200" lvl="5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3"/>
          <p:cNvSpPr txBox="1"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How to assay cortisol</a:t>
            </a:r>
            <a:endParaRPr/>
          </a:p>
        </p:txBody>
      </p:sp>
      <p:sp>
        <p:nvSpPr>
          <p:cNvPr id="85" name="Google Shape;85;p13"/>
          <p:cNvSpPr txBox="1">
            <a:spLocks noGrp="1"/>
          </p:cNvSpPr>
          <p:nvPr>
            <p:ph type="subTitle" idx="1"/>
          </p:nvPr>
        </p:nvSpPr>
        <p:spPr>
          <a:xfrm>
            <a:off x="1031500" y="3886200"/>
            <a:ext cx="7266900" cy="175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rgbClr val="888888"/>
              </a:buClr>
              <a:buSzPts val="3200"/>
              <a:buNone/>
            </a:pPr>
            <a:r>
              <a:rPr lang="en-US"/>
              <a:t>Dr. Erin Crockett</a:t>
            </a:r>
            <a:endParaRPr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rgbClr val="888888"/>
              </a:buClr>
              <a:buSzPts val="3200"/>
              <a:buNone/>
            </a:pPr>
            <a:r>
              <a:rPr lang="en-US"/>
              <a:t>Based on the Salimetrics Cortisol Protocol</a:t>
            </a:r>
            <a:endParaRPr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Google Shape;138;p22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Add start solution (multichannel)</a:t>
            </a:r>
            <a:endParaRPr/>
          </a:p>
        </p:txBody>
      </p:sp>
      <p:sp>
        <p:nvSpPr>
          <p:cNvPr id="139" name="Google Shape;139;p22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Add 200 uL of TMB solution to each well with a multi-channel</a:t>
            </a:r>
            <a:endParaRPr/>
          </a:p>
          <a:p>
            <a:pPr marL="0" lvl="0" indent="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endParaRPr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23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Mix the plate/Incubate</a:t>
            </a:r>
            <a:endParaRPr/>
          </a:p>
        </p:txBody>
      </p:sp>
      <p:sp>
        <p:nvSpPr>
          <p:cNvPr id="145" name="Google Shape;145;p23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Put plate on rotator for 5 minutes at 500 rpm</a:t>
            </a:r>
            <a:endParaRPr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Incubate for 25 minutes</a:t>
            </a:r>
            <a:endParaRPr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Google Shape;150;p24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Add stop solution (multichannel)</a:t>
            </a:r>
            <a:endParaRPr/>
          </a:p>
        </p:txBody>
      </p:sp>
      <p:sp>
        <p:nvSpPr>
          <p:cNvPr id="151" name="Google Shape;151;p24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Add 50 uL of stop solution to each well with a multi-channel</a:t>
            </a:r>
            <a:endParaRPr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Mix for 3 minutes at  500 rpm</a:t>
            </a:r>
            <a:endParaRPr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Wipe off bottom using lintless wipe</a:t>
            </a:r>
            <a:endParaRPr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Place in plate reader</a:t>
            </a:r>
            <a:endParaRPr/>
          </a:p>
          <a:p>
            <a:pPr marL="342900" lvl="0" indent="-1397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endParaRPr/>
          </a:p>
          <a:p>
            <a:pPr marL="0" lvl="0" indent="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14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Preparation</a:t>
            </a:r>
            <a:endParaRPr/>
          </a:p>
        </p:txBody>
      </p:sp>
      <p:sp>
        <p:nvSpPr>
          <p:cNvPr id="91" name="Google Shape;91;p14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Bring all samples/reagents to room temperatures</a:t>
            </a:r>
            <a:endParaRPr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Mix reagents</a:t>
            </a:r>
            <a:endParaRPr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Prepare wash buffer (100 mL of wash buffer with 900 mL of deionized H</a:t>
            </a:r>
            <a:r>
              <a:rPr lang="en-US" baseline="-25000"/>
              <a:t>2</a:t>
            </a:r>
            <a:r>
              <a:rPr lang="en-US"/>
              <a:t>0)</a:t>
            </a:r>
            <a:endParaRPr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Centrifuge samples: 15 mins @ 3000 rpm</a:t>
            </a:r>
            <a:endParaRPr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15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The layout of the plate</a:t>
            </a:r>
            <a:endParaRPr/>
          </a:p>
        </p:txBody>
      </p:sp>
      <p:graphicFrame>
        <p:nvGraphicFramePr>
          <p:cNvPr id="97" name="Google Shape;97;p15"/>
          <p:cNvGraphicFramePr/>
          <p:nvPr/>
        </p:nvGraphicFramePr>
        <p:xfrm>
          <a:off x="304801" y="1600200"/>
          <a:ext cx="8382050" cy="3337650"/>
        </p:xfrm>
        <a:graphic>
          <a:graphicData uri="http://schemas.openxmlformats.org/drawingml/2006/table">
            <a:tbl>
              <a:tblPr firstRow="1" bandRow="1">
                <a:noFill/>
                <a:tableStyleId>{07BD36B8-DC60-4912-8DF0-F89753BA78F9}</a:tableStyleId>
              </a:tblPr>
              <a:tblGrid>
                <a:gridCol w="533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0925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4477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4477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4477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4477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4477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644775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44775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44775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</a:tblGrid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2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3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4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5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6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7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8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9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0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1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2</a:t>
                      </a:r>
                      <a:endParaRPr sz="1800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A</a:t>
                      </a:r>
                      <a:endParaRPr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3.00</a:t>
                      </a:r>
                      <a:endParaRPr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3.00</a:t>
                      </a:r>
                      <a:endParaRPr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Ctrl-h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Ctrl-h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7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7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5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5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3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3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1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1</a:t>
                      </a:r>
                      <a:endParaRPr sz="1600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B 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1.00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1.00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Ctrl-l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Ctrl-l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8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8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6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6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4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4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2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2</a:t>
                      </a:r>
                      <a:endParaRPr sz="1600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C 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.333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.333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9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9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7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7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5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5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3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3</a:t>
                      </a:r>
                      <a:endParaRPr sz="1600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D 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.111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.111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0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0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8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8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6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6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4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4</a:t>
                      </a:r>
                      <a:endParaRPr sz="1600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E 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.037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.037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1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1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9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9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7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7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5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5</a:t>
                      </a:r>
                      <a:endParaRPr sz="1600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F 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.012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.012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4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4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2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2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0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0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8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8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6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6</a:t>
                      </a:r>
                      <a:endParaRPr sz="1600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G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Zero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Zero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5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5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3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3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1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1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9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9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7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7</a:t>
                      </a:r>
                      <a:endParaRPr sz="1600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H </a:t>
                      </a:r>
                      <a:endParaRPr sz="18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NSB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NSB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6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6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4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14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2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22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0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0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8</a:t>
                      </a:r>
                      <a:endParaRPr sz="1600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/>
                        <a:t>S #38</a:t>
                      </a:r>
                      <a:endParaRPr sz="1600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Google Shape;102;p16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Put strips in plate</a:t>
            </a:r>
            <a:endParaRPr/>
          </a:p>
        </p:txBody>
      </p:sp>
      <p:sp>
        <p:nvSpPr>
          <p:cNvPr id="103" name="Google Shape;103;p16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Remove bottom two wells and replace with non binding</a:t>
            </a:r>
            <a:endParaRPr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Place plate back in foil Ziploc bag</a:t>
            </a:r>
            <a:endParaRPr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p17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Use disposable pipette (mL)</a:t>
            </a:r>
            <a:endParaRPr/>
          </a:p>
        </p:txBody>
      </p:sp>
      <p:sp>
        <p:nvSpPr>
          <p:cNvPr id="109" name="Google Shape;109;p17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dirty="0"/>
              <a:t>Attach bulb onto the pipette</a:t>
            </a:r>
            <a:endParaRPr dirty="0"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dirty="0"/>
              <a:t>Pipette 24 mL of assay diluent into disposable tube</a:t>
            </a:r>
            <a:endParaRPr dirty="0"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dirty="0"/>
              <a:t>You will use this in step 5</a:t>
            </a:r>
            <a:endParaRPr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18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Single channel electric pipette</a:t>
            </a:r>
            <a:endParaRPr/>
          </a:p>
        </p:txBody>
      </p:sp>
      <p:sp>
        <p:nvSpPr>
          <p:cNvPr id="115" name="Google Shape;115;p18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dirty="0"/>
              <a:t>Pipette 25 </a:t>
            </a:r>
            <a:r>
              <a:rPr lang="en-US" dirty="0" err="1"/>
              <a:t>uL</a:t>
            </a:r>
            <a:r>
              <a:rPr lang="en-US" dirty="0"/>
              <a:t> of </a:t>
            </a:r>
            <a:r>
              <a:rPr lang="en-US" b="1" i="1" dirty="0"/>
              <a:t>standards</a:t>
            </a:r>
            <a:endParaRPr dirty="0"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dirty="0"/>
              <a:t>Pipette 25 </a:t>
            </a:r>
            <a:r>
              <a:rPr lang="en-US" dirty="0" err="1"/>
              <a:t>uL</a:t>
            </a:r>
            <a:r>
              <a:rPr lang="en-US" dirty="0"/>
              <a:t> of </a:t>
            </a:r>
            <a:r>
              <a:rPr lang="en-US" b="1" i="1" dirty="0"/>
              <a:t>assay diluent </a:t>
            </a:r>
            <a:r>
              <a:rPr lang="en-US" dirty="0"/>
              <a:t>into zero wells</a:t>
            </a:r>
            <a:endParaRPr dirty="0"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dirty="0"/>
              <a:t>Pipette 25 </a:t>
            </a:r>
            <a:r>
              <a:rPr lang="en-US" dirty="0" err="1"/>
              <a:t>ul</a:t>
            </a:r>
            <a:r>
              <a:rPr lang="en-US" dirty="0"/>
              <a:t> of </a:t>
            </a:r>
            <a:r>
              <a:rPr lang="en-US" b="1" i="1" dirty="0"/>
              <a:t>assay diluent </a:t>
            </a:r>
            <a:r>
              <a:rPr lang="en-US" dirty="0"/>
              <a:t>into NSB wells</a:t>
            </a:r>
            <a:endParaRPr dirty="0"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dirty="0"/>
              <a:t>Pipette 25 </a:t>
            </a:r>
            <a:r>
              <a:rPr lang="en-US" dirty="0" err="1"/>
              <a:t>uL</a:t>
            </a:r>
            <a:r>
              <a:rPr lang="en-US" dirty="0"/>
              <a:t> of </a:t>
            </a:r>
            <a:r>
              <a:rPr lang="en-US" b="1" i="1" dirty="0"/>
              <a:t>controls</a:t>
            </a:r>
            <a:endParaRPr dirty="0"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dirty="0"/>
              <a:t>Pipette 25 </a:t>
            </a:r>
            <a:r>
              <a:rPr lang="en-US" dirty="0" err="1"/>
              <a:t>uL</a:t>
            </a:r>
            <a:r>
              <a:rPr lang="en-US" dirty="0"/>
              <a:t> of </a:t>
            </a:r>
            <a:r>
              <a:rPr lang="en-US" b="1" i="1" dirty="0"/>
              <a:t>all samples </a:t>
            </a:r>
            <a:r>
              <a:rPr lang="en-US" dirty="0"/>
              <a:t>(make sure you keep track of which sample is in which well)</a:t>
            </a:r>
            <a:endParaRPr dirty="0"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dirty="0"/>
              <a:t>ALL SAMPLES SHOULD BE ASSAYED IN DUPLICATE</a:t>
            </a:r>
            <a:endParaRPr dirty="0"/>
          </a:p>
          <a:p>
            <a:pPr marL="342900" lvl="0" indent="-1397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endParaRPr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19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Make dilution/multichannel</a:t>
            </a:r>
            <a:endParaRPr/>
          </a:p>
        </p:txBody>
      </p:sp>
      <p:sp>
        <p:nvSpPr>
          <p:cNvPr id="121" name="Google Shape;121;p19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Add 15 uL of conjugate (which is everything that is in there) to the 24 mL of assay diluent set aside in step 3.</a:t>
            </a:r>
            <a:endParaRPr/>
          </a:p>
          <a:p>
            <a:pPr marL="342900" lvl="0" indent="-342900" algn="l" rtl="0">
              <a:lnSpc>
                <a:spcPct val="9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Mix the solution</a:t>
            </a:r>
            <a:endParaRPr/>
          </a:p>
          <a:p>
            <a:pPr marL="342900" lvl="0" indent="-342900" algn="l" rtl="0">
              <a:lnSpc>
                <a:spcPct val="9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Poor solution into well</a:t>
            </a:r>
            <a:endParaRPr/>
          </a:p>
          <a:p>
            <a:pPr marL="342900" lvl="0" indent="-342900" algn="l" rtl="0">
              <a:lnSpc>
                <a:spcPct val="9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Use multichannel to pipette 200 uL into each well. </a:t>
            </a:r>
            <a:endParaRPr/>
          </a:p>
          <a:p>
            <a:pPr marL="342900" lvl="0" indent="-342900" algn="l" rtl="0">
              <a:lnSpc>
                <a:spcPct val="9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 i="1"/>
              <a:t>Note: if there are any dark yellow or purple wells</a:t>
            </a:r>
            <a:endParaRPr/>
          </a:p>
          <a:p>
            <a:pPr marL="342900" lvl="0" indent="-139700" algn="l" rtl="0">
              <a:lnSpc>
                <a:spcPct val="9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endParaRPr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p20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Mix the plate/Incubate</a:t>
            </a:r>
            <a:endParaRPr/>
          </a:p>
        </p:txBody>
      </p:sp>
      <p:sp>
        <p:nvSpPr>
          <p:cNvPr id="127" name="Google Shape;127;p20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Put plate on rotator for 5 minutes at 500 rpm</a:t>
            </a:r>
            <a:endParaRPr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Incubate for 55 minutes</a:t>
            </a:r>
            <a:endParaRPr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Google Shape;132;p21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en-US"/>
              <a:t>Plate washer</a:t>
            </a:r>
            <a:endParaRPr/>
          </a:p>
        </p:txBody>
      </p:sp>
      <p:sp>
        <p:nvSpPr>
          <p:cNvPr id="133" name="Google Shape;133;p21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Wash the plate 4 times with 1X wash buffer</a:t>
            </a:r>
            <a:endParaRPr/>
          </a:p>
          <a:p>
            <a:pPr marL="342900" lvl="0" indent="-3429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</a:pPr>
            <a:r>
              <a:rPr lang="en-US"/>
              <a:t>Dry with a lintless wipe</a:t>
            </a:r>
            <a:endParaRPr/>
          </a:p>
          <a:p>
            <a:pPr marL="342900" lvl="0" indent="-1397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</a:pP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02</Words>
  <Application>Microsoft Macintosh PowerPoint</Application>
  <PresentationFormat>On-screen Show (4:3)</PresentationFormat>
  <Paragraphs>161</Paragraphs>
  <Slides>12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5" baseType="lpstr">
      <vt:lpstr>Arial</vt:lpstr>
      <vt:lpstr>Calibri</vt:lpstr>
      <vt:lpstr>Office Theme</vt:lpstr>
      <vt:lpstr>How to assay cortisol</vt:lpstr>
      <vt:lpstr>Preparation</vt:lpstr>
      <vt:lpstr>The layout of the plate</vt:lpstr>
      <vt:lpstr>Put strips in plate</vt:lpstr>
      <vt:lpstr>Use disposable pipette (mL)</vt:lpstr>
      <vt:lpstr>Single channel electric pipette</vt:lpstr>
      <vt:lpstr>Make dilution/multichannel</vt:lpstr>
      <vt:lpstr>Mix the plate/Incubate</vt:lpstr>
      <vt:lpstr>Plate washer</vt:lpstr>
      <vt:lpstr>Add start solution (multichannel)</vt:lpstr>
      <vt:lpstr>Mix the plate/Incubate</vt:lpstr>
      <vt:lpstr>Add stop solution (multichannel)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ow to assay cortisol</dc:title>
  <cp:lastModifiedBy>Microsoft Office User</cp:lastModifiedBy>
  <cp:revision>3</cp:revision>
  <dcterms:modified xsi:type="dcterms:W3CDTF">2019-03-08T17:44:51Z</dcterms:modified>
</cp:coreProperties>
</file>